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2BB546C-6480-1645-90E8-B0A4D9817C0D}" v="1" dt="2025-07-08T21:26:08.84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34"/>
    <p:restoredTop sz="94715"/>
  </p:normalViewPr>
  <p:slideViewPr>
    <p:cSldViewPr snapToGrid="0">
      <p:cViewPr>
        <p:scale>
          <a:sx n="98" d="100"/>
          <a:sy n="98" d="100"/>
        </p:scale>
        <p:origin x="1024" y="624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13" Type="http://schemas.microsoft.com/office/2015/10/relationships/revisionInfo" Target="revisionInfo.xml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customXml" Target="../customXml/item3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5" Type="http://schemas.openxmlformats.org/officeDocument/2006/relationships/customXml" Target="../customXml/item2.xml"/><Relationship Id="rId10" Type="http://schemas.openxmlformats.org/officeDocument/2006/relationships/viewProps" Target="viewProps.xml"/><Relationship Id="rId9" Type="http://schemas.openxmlformats.org/officeDocument/2006/relationships/presProps" Target="presProps.xml"/><Relationship Id="rId14" Type="http://schemas.openxmlformats.org/officeDocument/2006/relationships/customXml" Target="../customXml/item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>
          <a:extLst>
            <a:ext uri="{FF2B5EF4-FFF2-40B4-BE49-F238E27FC236}">
              <a16:creationId xmlns:a16="http://schemas.microsoft.com/office/drawing/2014/main" id="{13BC7E26-0CB3-27F7-A043-A3730760D1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>
            <a:extLst>
              <a:ext uri="{FF2B5EF4-FFF2-40B4-BE49-F238E27FC236}">
                <a16:creationId xmlns:a16="http://schemas.microsoft.com/office/drawing/2014/main" id="{F655E726-08E6-7086-E635-C836CE05DA40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>
            <a:extLst>
              <a:ext uri="{FF2B5EF4-FFF2-40B4-BE49-F238E27FC236}">
                <a16:creationId xmlns:a16="http://schemas.microsoft.com/office/drawing/2014/main" id="{0F144223-BCC8-B8D8-BABE-0A52CF0A0B04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>
            <a:extLst>
              <a:ext uri="{FF2B5EF4-FFF2-40B4-BE49-F238E27FC236}">
                <a16:creationId xmlns:a16="http://schemas.microsoft.com/office/drawing/2014/main" id="{5501BF73-852C-A5E9-11DC-0797E374B305}"/>
              </a:ext>
            </a:extLst>
          </p:cNvPr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7767327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5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6" Type="http://schemas.openxmlformats.org/officeDocument/2006/relationships/hyperlink" Target="https://biorender.com/icon/patient-chart" TargetMode="Externa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>
          <a:extLst>
            <a:ext uri="{FF2B5EF4-FFF2-40B4-BE49-F238E27FC236}">
              <a16:creationId xmlns:a16="http://schemas.microsoft.com/office/drawing/2014/main" id="{50011630-1974-2076-308E-F62D85E1BF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1">
            <a:extLst>
              <a:ext uri="{FF2B5EF4-FFF2-40B4-BE49-F238E27FC236}">
                <a16:creationId xmlns:a16="http://schemas.microsoft.com/office/drawing/2014/main" id="{2E33B79A-621E-2964-FE2F-FDF8D00088BE}"/>
              </a:ext>
            </a:extLst>
          </p:cNvPr>
          <p:cNvSpPr txBox="1"/>
          <p:nvPr/>
        </p:nvSpPr>
        <p:spPr>
          <a:xfrm>
            <a:off x="11944" y="2067123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>
            <a:extLst>
              <a:ext uri="{FF2B5EF4-FFF2-40B4-BE49-F238E27FC236}">
                <a16:creationId xmlns:a16="http://schemas.microsoft.com/office/drawing/2014/main" id="{206D7FCE-6514-E3B5-B610-456455468CC3}"/>
              </a:ext>
            </a:extLst>
          </p:cNvPr>
          <p:cNvSpPr txBox="1"/>
          <p:nvPr/>
        </p:nvSpPr>
        <p:spPr>
          <a:xfrm>
            <a:off x="778644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9" name="Google Shape;99;p1">
            <a:extLst>
              <a:ext uri="{FF2B5EF4-FFF2-40B4-BE49-F238E27FC236}">
                <a16:creationId xmlns:a16="http://schemas.microsoft.com/office/drawing/2014/main" id="{E8117AB9-83D2-B6F4-267C-90034B2B42A2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976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">
            <a:extLst>
              <a:ext uri="{FF2B5EF4-FFF2-40B4-BE49-F238E27FC236}">
                <a16:creationId xmlns:a16="http://schemas.microsoft.com/office/drawing/2014/main" id="{42DC8238-9ADA-2364-E8D1-13DB526974A7}"/>
              </a:ext>
            </a:extLst>
          </p:cNvPr>
          <p:cNvSpPr/>
          <p:nvPr/>
        </p:nvSpPr>
        <p:spPr>
          <a:xfrm>
            <a:off x="-9788" y="1549155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1" name="Google Shape;101;p1">
            <a:extLst>
              <a:ext uri="{FF2B5EF4-FFF2-40B4-BE49-F238E27FC236}">
                <a16:creationId xmlns:a16="http://schemas.microsoft.com/office/drawing/2014/main" id="{AFD08C1F-85D0-8A13-E013-70E86478B09D}"/>
              </a:ext>
            </a:extLst>
          </p:cNvPr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>
              <a:extLst>
                <a:ext uri="{FF2B5EF4-FFF2-40B4-BE49-F238E27FC236}">
                  <a16:creationId xmlns:a16="http://schemas.microsoft.com/office/drawing/2014/main" id="{36793371-7D76-1B93-336F-CCED6B470066}"/>
                </a:ext>
              </a:extLst>
            </p:cNvPr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                       @ThoraxBMJ</a:t>
              </a:r>
              <a:endParaRPr sz="1725" b="1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>
              <a:extLst>
                <a:ext uri="{FF2B5EF4-FFF2-40B4-BE49-F238E27FC236}">
                  <a16:creationId xmlns:a16="http://schemas.microsoft.com/office/drawing/2014/main" id="{217F8E39-7AB5-8723-8008-E5D06875504E}"/>
                </a:ext>
              </a:extLst>
            </p:cNvPr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>
            <a:extLst>
              <a:ext uri="{FF2B5EF4-FFF2-40B4-BE49-F238E27FC236}">
                <a16:creationId xmlns:a16="http://schemas.microsoft.com/office/drawing/2014/main" id="{AFC2CAF6-C799-2764-691B-5D770C7A3884}"/>
              </a:ext>
            </a:extLst>
          </p:cNvPr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>
            <a:extLst>
              <a:ext uri="{FF2B5EF4-FFF2-40B4-BE49-F238E27FC236}">
                <a16:creationId xmlns:a16="http://schemas.microsoft.com/office/drawing/2014/main" id="{8870427E-0BAF-B520-C035-CF78E4B6D1C0}"/>
              </a:ext>
            </a:extLst>
          </p:cNvPr>
          <p:cNvSpPr txBox="1"/>
          <p:nvPr/>
        </p:nvSpPr>
        <p:spPr>
          <a:xfrm>
            <a:off x="79541" y="330236"/>
            <a:ext cx="8984918" cy="623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sz="1575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cute breathlessness as a cause of hospitalisation in Malawi: a prospective, </a:t>
            </a:r>
            <a:r>
              <a:rPr lang="en-GB" sz="1575" b="1" i="0" u="none" strike="noStrike" cap="none" noProof="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atient-centred</a:t>
            </a:r>
            <a:r>
              <a:rPr lang="en-US" sz="1575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study to evaluate causes and outcomes</a:t>
            </a:r>
          </a:p>
        </p:txBody>
      </p:sp>
      <p:sp>
        <p:nvSpPr>
          <p:cNvPr id="106" name="Google Shape;106;p1">
            <a:extLst>
              <a:ext uri="{FF2B5EF4-FFF2-40B4-BE49-F238E27FC236}">
                <a16:creationId xmlns:a16="http://schemas.microsoft.com/office/drawing/2014/main" id="{2BF787B3-480C-E546-1B24-FAA0A06C90CE}"/>
              </a:ext>
            </a:extLst>
          </p:cNvPr>
          <p:cNvSpPr txBox="1"/>
          <p:nvPr/>
        </p:nvSpPr>
        <p:spPr>
          <a:xfrm>
            <a:off x="127002" y="1754015"/>
            <a:ext cx="2870030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7" name="Google Shape;107;p1">
            <a:extLst>
              <a:ext uri="{FF2B5EF4-FFF2-40B4-BE49-F238E27FC236}">
                <a16:creationId xmlns:a16="http://schemas.microsoft.com/office/drawing/2014/main" id="{8A8AAD0A-E5A1-3B0B-BAB2-31B5373AC6ED}"/>
              </a:ext>
            </a:extLst>
          </p:cNvPr>
          <p:cNvSpPr txBox="1"/>
          <p:nvPr/>
        </p:nvSpPr>
        <p:spPr>
          <a:xfrm>
            <a:off x="3110439" y="1767196"/>
            <a:ext cx="2851475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8" name="Google Shape;108;p1">
            <a:extLst>
              <a:ext uri="{FF2B5EF4-FFF2-40B4-BE49-F238E27FC236}">
                <a16:creationId xmlns:a16="http://schemas.microsoft.com/office/drawing/2014/main" id="{D37DC671-143B-EEA6-2A3A-3562BD2663B5}"/>
              </a:ext>
            </a:extLst>
          </p:cNvPr>
          <p:cNvSpPr txBox="1"/>
          <p:nvPr/>
        </p:nvSpPr>
        <p:spPr>
          <a:xfrm>
            <a:off x="6127994" y="1767196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9" name="Google Shape;109;p1" descr="About Twitter | Our logo, brand guidelines, and Tweet tools">
            <a:extLst>
              <a:ext uri="{FF2B5EF4-FFF2-40B4-BE49-F238E27FC236}">
                <a16:creationId xmlns:a16="http://schemas.microsoft.com/office/drawing/2014/main" id="{B51D6AD1-2A6F-14E2-E818-2CD5D2A31BDF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>
            <a:extLst>
              <a:ext uri="{FF2B5EF4-FFF2-40B4-BE49-F238E27FC236}">
                <a16:creationId xmlns:a16="http://schemas.microsoft.com/office/drawing/2014/main" id="{4D1487D6-03A9-0603-A2F4-E36C7EEC2E36}"/>
              </a:ext>
            </a:extLst>
          </p:cNvPr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>
            <a:extLst>
              <a:ext uri="{FF2B5EF4-FFF2-40B4-BE49-F238E27FC236}">
                <a16:creationId xmlns:a16="http://schemas.microsoft.com/office/drawing/2014/main" id="{3452B7BD-CBB8-4824-507B-9FAAFE1636CC}"/>
              </a:ext>
            </a:extLst>
          </p:cNvPr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E7542A7-0940-22DE-7588-7F99EA8784A6}"/>
              </a:ext>
            </a:extLst>
          </p:cNvPr>
          <p:cNvSpPr txBox="1"/>
          <p:nvPr/>
        </p:nvSpPr>
        <p:spPr>
          <a:xfrm>
            <a:off x="774997" y="2290314"/>
            <a:ext cx="21047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dults (≥18) acutely admitted to hospital</a:t>
            </a:r>
          </a:p>
        </p:txBody>
      </p:sp>
      <p:pic>
        <p:nvPicPr>
          <p:cNvPr id="1030" name="Picture 6">
            <a:extLst>
              <a:ext uri="{FF2B5EF4-FFF2-40B4-BE49-F238E27FC236}">
                <a16:creationId xmlns:a16="http://schemas.microsoft.com/office/drawing/2014/main" id="{4ED5272E-0362-8ABF-E7CC-B3EE88BD430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069" y="2191122"/>
            <a:ext cx="541156" cy="5411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98B49E4-B2A8-81E6-FBF6-36FE2D759FB4}"/>
              </a:ext>
            </a:extLst>
          </p:cNvPr>
          <p:cNvSpPr txBox="1"/>
          <p:nvPr/>
        </p:nvSpPr>
        <p:spPr>
          <a:xfrm>
            <a:off x="766836" y="2856974"/>
            <a:ext cx="225414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esentation with breathlessness, defined as a composite of:</a:t>
            </a:r>
          </a:p>
          <a:p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. Patient-reported shortness of breath</a:t>
            </a:r>
          </a:p>
          <a:p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. Tachypnoea (RR ≥25/min]</a:t>
            </a:r>
          </a:p>
          <a:p>
            <a:endParaRPr lang="en-GB" sz="1000" dirty="0">
              <a:solidFill>
                <a:srgbClr val="0070C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. Hypoxaemia (SpO₂&lt;94%) or treatment with oxygen therapy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D242E88-AB95-C7D9-BC2F-7C988F80A2BE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15839" t="8995" r="18667" b="8822"/>
          <a:stretch>
            <a:fillRect/>
          </a:stretch>
        </p:blipFill>
        <p:spPr>
          <a:xfrm>
            <a:off x="241896" y="2942056"/>
            <a:ext cx="411532" cy="455439"/>
          </a:xfrm>
          <a:prstGeom prst="rect">
            <a:avLst/>
          </a:prstGeom>
        </p:spPr>
      </p:pic>
      <p:pic>
        <p:nvPicPr>
          <p:cNvPr id="1036" name="Picture 12">
            <a:extLst>
              <a:ext uri="{FF2B5EF4-FFF2-40B4-BE49-F238E27FC236}">
                <a16:creationId xmlns:a16="http://schemas.microsoft.com/office/drawing/2014/main" id="{09BCB31C-2A10-E3C4-0FDF-B5C54C5E3F3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503" y="3524594"/>
            <a:ext cx="582503" cy="5825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26C3085-719B-5D5A-F4BD-283CAB55CF6C}"/>
              </a:ext>
            </a:extLst>
          </p:cNvPr>
          <p:cNvSpPr txBox="1"/>
          <p:nvPr/>
        </p:nvSpPr>
        <p:spPr>
          <a:xfrm>
            <a:off x="726174" y="4385273"/>
            <a:ext cx="210477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wo hospitals in Malawi: </a:t>
            </a:r>
          </a:p>
          <a:p>
            <a:pPr marL="171450" indent="-171450">
              <a:buFontTx/>
              <a:buChar char="-"/>
            </a:pPr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One tertiary (central) hospital</a:t>
            </a:r>
          </a:p>
          <a:p>
            <a:pPr marL="171450" indent="-171450">
              <a:buFontTx/>
              <a:buChar char="-"/>
            </a:pPr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One secondary (district) hospita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A14702D-44D2-64B3-F515-B0D18FE8D5D1}"/>
              </a:ext>
            </a:extLst>
          </p:cNvPr>
          <p:cNvSpPr txBox="1"/>
          <p:nvPr/>
        </p:nvSpPr>
        <p:spPr>
          <a:xfrm>
            <a:off x="3232243" y="1837161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ETHODS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EDD5704-F7A5-6BD2-761F-B0B39AEC227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08245" y="2327885"/>
            <a:ext cx="519859" cy="55946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E972045-723F-4EAD-35C4-898E63048C5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855129" y="2386965"/>
            <a:ext cx="227422" cy="42808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7E4A9D52-F40E-D7DB-D32E-DCE92AC10412}"/>
              </a:ext>
            </a:extLst>
          </p:cNvPr>
          <p:cNvSpPr txBox="1"/>
          <p:nvPr/>
        </p:nvSpPr>
        <p:spPr>
          <a:xfrm>
            <a:off x="162922" y="1838094"/>
            <a:ext cx="1176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OPULAT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AA3AC6-8074-D224-7D19-FF53FA3AC62C}"/>
              </a:ext>
            </a:extLst>
          </p:cNvPr>
          <p:cNvSpPr txBox="1"/>
          <p:nvPr/>
        </p:nvSpPr>
        <p:spPr>
          <a:xfrm>
            <a:off x="4151463" y="2330619"/>
            <a:ext cx="160744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anel of diagnostic tests systematically applied to all participants</a:t>
            </a:r>
          </a:p>
        </p:txBody>
      </p:sp>
      <p:pic>
        <p:nvPicPr>
          <p:cNvPr id="1046" name="Picture 22">
            <a:extLst>
              <a:ext uri="{FF2B5EF4-FFF2-40B4-BE49-F238E27FC236}">
                <a16:creationId xmlns:a16="http://schemas.microsoft.com/office/drawing/2014/main" id="{07765F83-915A-1596-73BB-2B606B0551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3338" y="3248938"/>
            <a:ext cx="523778" cy="523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198B8F3-EA67-099C-FE3C-6491353515BD}"/>
              </a:ext>
            </a:extLst>
          </p:cNvPr>
          <p:cNvSpPr txBox="1"/>
          <p:nvPr/>
        </p:nvSpPr>
        <p:spPr>
          <a:xfrm>
            <a:off x="4154140" y="3348404"/>
            <a:ext cx="1560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ollow-up for one-year after hospital admissio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5BF9515-A572-85EC-63CC-326A67062F67}"/>
              </a:ext>
            </a:extLst>
          </p:cNvPr>
          <p:cNvSpPr txBox="1"/>
          <p:nvPr/>
        </p:nvSpPr>
        <p:spPr>
          <a:xfrm>
            <a:off x="6263028" y="1870784"/>
            <a:ext cx="912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NDINGS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46AA3C68-4621-3C82-04B3-23C1220D69E3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 l="2053" t="54567" r="88215" b="11327"/>
          <a:stretch>
            <a:fillRect/>
          </a:stretch>
        </p:blipFill>
        <p:spPr>
          <a:xfrm>
            <a:off x="6134505" y="2383956"/>
            <a:ext cx="1017206" cy="1268054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FFB315EE-50D3-2F7B-91EF-45BDA652E357}"/>
              </a:ext>
            </a:extLst>
          </p:cNvPr>
          <p:cNvSpPr txBox="1"/>
          <p:nvPr/>
        </p:nvSpPr>
        <p:spPr>
          <a:xfrm>
            <a:off x="59321" y="1130804"/>
            <a:ext cx="50081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pencer SA, et al. </a:t>
            </a:r>
            <a:r>
              <a:rPr lang="en-GB" i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horax</a:t>
            </a:r>
            <a:r>
              <a:rPr lang="en-GB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2025. DOI: 10.1136/thorax-2025-22362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B6DFE22-919A-0672-E5BC-B2046F1E6252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 l="81651" t="53105" r="2079" b="5970"/>
          <a:stretch>
            <a:fillRect/>
          </a:stretch>
        </p:blipFill>
        <p:spPr>
          <a:xfrm>
            <a:off x="7158222" y="2312634"/>
            <a:ext cx="1715778" cy="153536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11194A0-2060-4EF0-2FD1-F87C4236AAAD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 l="85717" t="11433" r="12145" b="49970"/>
          <a:stretch>
            <a:fillRect/>
          </a:stretch>
        </p:blipFill>
        <p:spPr>
          <a:xfrm rot="16200000">
            <a:off x="7912024" y="1915169"/>
            <a:ext cx="139536" cy="89922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AC17000-6ED2-54FA-0F97-191331BDBF95}"/>
              </a:ext>
            </a:extLst>
          </p:cNvPr>
          <p:cNvSpPr txBox="1"/>
          <p:nvPr/>
        </p:nvSpPr>
        <p:spPr>
          <a:xfrm>
            <a:off x="7745990" y="3766307"/>
            <a:ext cx="5293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eval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1A76578-BA91-7199-B74C-83A06CD56862}"/>
              </a:ext>
            </a:extLst>
          </p:cNvPr>
          <p:cNvSpPr txBox="1"/>
          <p:nvPr/>
        </p:nvSpPr>
        <p:spPr>
          <a:xfrm>
            <a:off x="7255768" y="2077171"/>
            <a:ext cx="13485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Number of co-existing aetiologies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ABF5A52E-7C28-A25C-5ABA-C700FEA948D2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 t="6292"/>
          <a:stretch>
            <a:fillRect/>
          </a:stretch>
        </p:blipFill>
        <p:spPr>
          <a:xfrm>
            <a:off x="6709278" y="4016250"/>
            <a:ext cx="1844197" cy="159522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0F96F33-2346-3E1A-9459-15184DCEE03B}"/>
              </a:ext>
            </a:extLst>
          </p:cNvPr>
          <p:cNvSpPr txBox="1"/>
          <p:nvPr/>
        </p:nvSpPr>
        <p:spPr>
          <a:xfrm>
            <a:off x="7512518" y="2169504"/>
            <a:ext cx="85648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    2     3    4     5    6     7</a:t>
            </a:r>
          </a:p>
        </p:txBody>
      </p:sp>
      <p:pic>
        <p:nvPicPr>
          <p:cNvPr id="2054" name="Picture 6">
            <a:hlinkClick r:id="rId16"/>
            <a:extLst>
              <a:ext uri="{FF2B5EF4-FFF2-40B4-BE49-F238E27FC236}">
                <a16:creationId xmlns:a16="http://schemas.microsoft.com/office/drawing/2014/main" id="{058CED45-5BDE-CFF6-6F66-6E8D3CB79D9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2" t="12314" r="12862" b="12942"/>
          <a:stretch>
            <a:fillRect/>
          </a:stretch>
        </p:blipFill>
        <p:spPr bwMode="auto">
          <a:xfrm>
            <a:off x="3319965" y="4107097"/>
            <a:ext cx="722367" cy="9938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75C25FDB-4BAF-F975-7624-B641CB055678}"/>
              </a:ext>
            </a:extLst>
          </p:cNvPr>
          <p:cNvSpPr txBox="1"/>
          <p:nvPr/>
        </p:nvSpPr>
        <p:spPr>
          <a:xfrm>
            <a:off x="4107663" y="4139294"/>
            <a:ext cx="201701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Outcome measures:</a:t>
            </a:r>
            <a:endParaRPr lang="en-GB" sz="1000" dirty="0">
              <a:solidFill>
                <a:srgbClr val="0070C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evalence of aetiologi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urvival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ealth-related quality of lif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unctional status</a:t>
            </a:r>
          </a:p>
          <a:p>
            <a:endParaRPr lang="en-GB" sz="1000" dirty="0">
              <a:solidFill>
                <a:srgbClr val="0070C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GB" sz="1000" dirty="0">
              <a:solidFill>
                <a:srgbClr val="0070C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7BC12A49-81B7-722D-BE3F-4790ED0832BC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05470" y="4246117"/>
            <a:ext cx="567756" cy="950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5127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AB33A644E90814CBF8644EDF18D499C" ma:contentTypeVersion="15" ma:contentTypeDescription="Create a new document." ma:contentTypeScope="" ma:versionID="681a790a952e31e8fd2fa9292fd712a6">
  <xsd:schema xmlns:xsd="http://www.w3.org/2001/XMLSchema" xmlns:xs="http://www.w3.org/2001/XMLSchema" xmlns:p="http://schemas.microsoft.com/office/2006/metadata/properties" xmlns:ns2="a2186e0b-21c5-469f-93cf-62040f8a8f4e" xmlns:ns3="728e793a-e138-42ba-9acf-6c1f4c5eb08b" targetNamespace="http://schemas.microsoft.com/office/2006/metadata/properties" ma:root="true" ma:fieldsID="ee17b5d7f188cb2b09deb5107e4ed7a9" ns2:_="" ns3:_="">
    <xsd:import namespace="a2186e0b-21c5-469f-93cf-62040f8a8f4e"/>
    <xsd:import namespace="728e793a-e138-42ba-9acf-6c1f4c5eb08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186e0b-21c5-469f-93cf-62040f8a8f4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2e10342f-3527-4dcd-ac28-e59db492a80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2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28e793a-e138-42ba-9acf-6c1f4c5eb08b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8" nillable="true" ma:displayName="Taxonomy Catch All Column" ma:hidden="true" ma:list="{8abbc91a-5509-4e53-8106-a54ac67e539e}" ma:internalName="TaxCatchAll" ma:showField="CatchAllData" ma:web="728e793a-e138-42ba-9acf-6c1f4c5eb08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728e793a-e138-42ba-9acf-6c1f4c5eb08b" xsi:nil="true"/>
    <lcf76f155ced4ddcb4097134ff3c332f xmlns="a2186e0b-21c5-469f-93cf-62040f8a8f4e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41594C0D-BD42-4F88-8CDB-76073FD632FA}"/>
</file>

<file path=customXml/itemProps2.xml><?xml version="1.0" encoding="utf-8"?>
<ds:datastoreItem xmlns:ds="http://schemas.openxmlformats.org/officeDocument/2006/customXml" ds:itemID="{077AF5FB-DC68-46D6-AC20-1755C649E18B}"/>
</file>

<file path=customXml/itemProps3.xml><?xml version="1.0" encoding="utf-8"?>
<ds:datastoreItem xmlns:ds="http://schemas.openxmlformats.org/officeDocument/2006/customXml" ds:itemID="{08FADEAD-D864-485E-9594-BCC7A81689D9}"/>
</file>

<file path=docProps/app.xml><?xml version="1.0" encoding="utf-8"?>
<Properties xmlns="http://schemas.openxmlformats.org/officeDocument/2006/extended-properties" xmlns:vt="http://schemas.openxmlformats.org/officeDocument/2006/docPropsVTypes">
  <TotalTime>1406</TotalTime>
  <Words>178</Words>
  <Application>Microsoft Macintosh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olantonio</dc:creator>
  <cp:lastModifiedBy>Stephen Spencer</cp:lastModifiedBy>
  <cp:revision>1</cp:revision>
  <dcterms:created xsi:type="dcterms:W3CDTF">2018-02-16T17:34:16Z</dcterms:created>
  <dcterms:modified xsi:type="dcterms:W3CDTF">2025-07-08T21:26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AB33A644E90814CBF8644EDF18D499C</vt:lpwstr>
  </property>
</Properties>
</file>